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2" r:id="rId2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9"/>
    <p:restoredTop sz="94660"/>
  </p:normalViewPr>
  <p:slideViewPr>
    <p:cSldViewPr snapToGrid="0">
      <p:cViewPr>
        <p:scale>
          <a:sx n="81" d="100"/>
          <a:sy n="81" d="100"/>
        </p:scale>
        <p:origin x="-5184" y="-12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2" d="100"/>
          <a:sy n="52" d="100"/>
        </p:scale>
        <p:origin x="2958" y="9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76363" cy="513508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5" y="2"/>
            <a:ext cx="3076363" cy="513508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r">
              <a:defRPr sz="1200"/>
            </a:lvl1pPr>
          </a:lstStyle>
          <a:p>
            <a:fld id="{9D67A089-3EC3-4620-BEEE-B1748E8A2621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54250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8" tIns="47384" rIns="94768" bIns="473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1" y="4925407"/>
            <a:ext cx="5679440" cy="4029879"/>
          </a:xfrm>
          <a:prstGeom prst="rect">
            <a:avLst/>
          </a:prstGeom>
        </p:spPr>
        <p:txBody>
          <a:bodyPr vert="horz" lIns="94768" tIns="47384" rIns="94768" bIns="4738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721108"/>
            <a:ext cx="3076363" cy="513507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5" y="9721108"/>
            <a:ext cx="3076363" cy="513507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r">
              <a:defRPr sz="1200"/>
            </a:lvl1pPr>
          </a:lstStyle>
          <a:p>
            <a:fld id="{8B992F4F-6D07-4AA1-BEBD-0C3C3AE2D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905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10" indent="0" algn="ctr">
              <a:buNone/>
              <a:defRPr sz="1500"/>
            </a:lvl2pPr>
            <a:lvl3pPr marL="685822" indent="0" algn="ctr">
              <a:buNone/>
              <a:defRPr sz="1350"/>
            </a:lvl3pPr>
            <a:lvl4pPr marL="1028732" indent="0" algn="ctr">
              <a:buNone/>
              <a:defRPr sz="1200"/>
            </a:lvl4pPr>
            <a:lvl5pPr marL="1371643" indent="0" algn="ctr">
              <a:buNone/>
              <a:defRPr sz="1200"/>
            </a:lvl5pPr>
            <a:lvl6pPr marL="1714553" indent="0" algn="ctr">
              <a:buNone/>
              <a:defRPr sz="1200"/>
            </a:lvl6pPr>
            <a:lvl7pPr marL="2057465" indent="0" algn="ctr">
              <a:buNone/>
              <a:defRPr sz="1200"/>
            </a:lvl7pPr>
            <a:lvl8pPr marL="2400375" indent="0" algn="ctr">
              <a:buNone/>
              <a:defRPr sz="1200"/>
            </a:lvl8pPr>
            <a:lvl9pPr marL="2743285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92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988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6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6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20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056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5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1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2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6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683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57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8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3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0" indent="0">
              <a:buNone/>
              <a:defRPr sz="1500" b="1"/>
            </a:lvl2pPr>
            <a:lvl3pPr marL="685822" indent="0">
              <a:buNone/>
              <a:defRPr sz="1350" b="1"/>
            </a:lvl3pPr>
            <a:lvl4pPr marL="1028732" indent="0">
              <a:buNone/>
              <a:defRPr sz="1200" b="1"/>
            </a:lvl4pPr>
            <a:lvl5pPr marL="1371643" indent="0">
              <a:buNone/>
              <a:defRPr sz="1200" b="1"/>
            </a:lvl5pPr>
            <a:lvl6pPr marL="1714553" indent="0">
              <a:buNone/>
              <a:defRPr sz="1200" b="1"/>
            </a:lvl6pPr>
            <a:lvl7pPr marL="2057465" indent="0">
              <a:buNone/>
              <a:defRPr sz="1200" b="1"/>
            </a:lvl7pPr>
            <a:lvl8pPr marL="2400375" indent="0">
              <a:buNone/>
              <a:defRPr sz="1200" b="1"/>
            </a:lvl8pPr>
            <a:lvl9pPr marL="274328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3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0" indent="0">
              <a:buNone/>
              <a:defRPr sz="1500" b="1"/>
            </a:lvl2pPr>
            <a:lvl3pPr marL="685822" indent="0">
              <a:buNone/>
              <a:defRPr sz="1350" b="1"/>
            </a:lvl3pPr>
            <a:lvl4pPr marL="1028732" indent="0">
              <a:buNone/>
              <a:defRPr sz="1200" b="1"/>
            </a:lvl4pPr>
            <a:lvl5pPr marL="1371643" indent="0">
              <a:buNone/>
              <a:defRPr sz="1200" b="1"/>
            </a:lvl5pPr>
            <a:lvl6pPr marL="1714553" indent="0">
              <a:buNone/>
              <a:defRPr sz="1200" b="1"/>
            </a:lvl6pPr>
            <a:lvl7pPr marL="2057465" indent="0">
              <a:buNone/>
              <a:defRPr sz="1200" b="1"/>
            </a:lvl7pPr>
            <a:lvl8pPr marL="2400375" indent="0">
              <a:buNone/>
              <a:defRPr sz="1200" b="1"/>
            </a:lvl8pPr>
            <a:lvl9pPr marL="274328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447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34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96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0" indent="0">
              <a:buNone/>
              <a:defRPr sz="1050"/>
            </a:lvl2pPr>
            <a:lvl3pPr marL="685822" indent="0">
              <a:buNone/>
              <a:defRPr sz="900"/>
            </a:lvl3pPr>
            <a:lvl4pPr marL="1028732" indent="0">
              <a:buNone/>
              <a:defRPr sz="750"/>
            </a:lvl4pPr>
            <a:lvl5pPr marL="1371643" indent="0">
              <a:buNone/>
              <a:defRPr sz="750"/>
            </a:lvl5pPr>
            <a:lvl6pPr marL="1714553" indent="0">
              <a:buNone/>
              <a:defRPr sz="750"/>
            </a:lvl6pPr>
            <a:lvl7pPr marL="2057465" indent="0">
              <a:buNone/>
              <a:defRPr sz="750"/>
            </a:lvl7pPr>
            <a:lvl8pPr marL="2400375" indent="0">
              <a:buNone/>
              <a:defRPr sz="750"/>
            </a:lvl8pPr>
            <a:lvl9pPr marL="2743285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583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10" indent="0">
              <a:buNone/>
              <a:defRPr sz="2100"/>
            </a:lvl2pPr>
            <a:lvl3pPr marL="685822" indent="0">
              <a:buNone/>
              <a:defRPr sz="1800"/>
            </a:lvl3pPr>
            <a:lvl4pPr marL="1028732" indent="0">
              <a:buNone/>
              <a:defRPr sz="1500"/>
            </a:lvl4pPr>
            <a:lvl5pPr marL="1371643" indent="0">
              <a:buNone/>
              <a:defRPr sz="1500"/>
            </a:lvl5pPr>
            <a:lvl6pPr marL="1714553" indent="0">
              <a:buNone/>
              <a:defRPr sz="1500"/>
            </a:lvl6pPr>
            <a:lvl7pPr marL="2057465" indent="0">
              <a:buNone/>
              <a:defRPr sz="1500"/>
            </a:lvl7pPr>
            <a:lvl8pPr marL="2400375" indent="0">
              <a:buNone/>
              <a:defRPr sz="1500"/>
            </a:lvl8pPr>
            <a:lvl9pPr marL="2743285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0" indent="0">
              <a:buNone/>
              <a:defRPr sz="1050"/>
            </a:lvl2pPr>
            <a:lvl3pPr marL="685822" indent="0">
              <a:buNone/>
              <a:defRPr sz="900"/>
            </a:lvl3pPr>
            <a:lvl4pPr marL="1028732" indent="0">
              <a:buNone/>
              <a:defRPr sz="750"/>
            </a:lvl4pPr>
            <a:lvl5pPr marL="1371643" indent="0">
              <a:buNone/>
              <a:defRPr sz="750"/>
            </a:lvl5pPr>
            <a:lvl6pPr marL="1714553" indent="0">
              <a:buNone/>
              <a:defRPr sz="750"/>
            </a:lvl6pPr>
            <a:lvl7pPr marL="2057465" indent="0">
              <a:buNone/>
              <a:defRPr sz="750"/>
            </a:lvl7pPr>
            <a:lvl8pPr marL="2400375" indent="0">
              <a:buNone/>
              <a:defRPr sz="750"/>
            </a:lvl8pPr>
            <a:lvl9pPr marL="2743285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257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A2D3-1E85-4B8F-B11B-1D94F4B19A4E}" type="datetimeFigureOut">
              <a:rPr lang="en-US" smtClean="0"/>
              <a:t>10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88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2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6" indent="-171456" algn="l" defTabSz="68582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6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77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88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98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009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919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831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741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10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22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32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43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53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6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7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8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1653471"/>
              </p:ext>
            </p:extLst>
          </p:nvPr>
        </p:nvGraphicFramePr>
        <p:xfrm>
          <a:off x="336429" y="777181"/>
          <a:ext cx="6167887" cy="7218704"/>
        </p:xfrm>
        <a:graphic>
          <a:graphicData uri="http://schemas.openxmlformats.org/drawingml/2006/table">
            <a:tbl>
              <a:tblPr firstRow="1" firstCol="1" bandRow="1"/>
              <a:tblGrid>
                <a:gridCol w="2308133"/>
                <a:gridCol w="2013785"/>
                <a:gridCol w="1845969"/>
              </a:tblGrid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rimer Name</a:t>
                      </a:r>
                      <a:endParaRPr lang="ja-JP" sz="900" b="1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8097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equence 5ʹ-3ʹ</a:t>
                      </a:r>
                      <a:endParaRPr lang="ja-JP" sz="900" b="1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Usage</a:t>
                      </a:r>
                      <a:endParaRPr lang="ja-JP" sz="900" b="1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3975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KF1 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AGGGTCCTGAGATCCGTA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aseline="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artial 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DNA clonin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KR1 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GCAGATGACGCAAGAGACT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artial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EPtaseF1 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TGATTTGGGGCAGACATTT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artial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EPtaseR1 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TCATGATTTCCAGCAGTCC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aseline="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artial 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DNA clonin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EPCF1 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GGAGGTCCCTGCTCCAGA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artial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23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EPCR1 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TGACCCTGAAGAATGGCCACT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artial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EPCKF1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TCAGCGACAGCTCCCTCA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artial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EPCKR1 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GCGAACACCTCGAAGTTCTT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572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artial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F2-3′RACE 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ACCGATGTTGCCAATGCTGTT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RACE clonin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F3-3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GACAGGTTCTTGGGCCTTATG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F4-3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CGTCGTCACTGCCACTCAAAT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R2-5′RACE 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ACAGTCAGTGCCGTCAAGAAC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R3-5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AGGGAGGACTCTGCCTCGTTA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R4-5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TCCAGGGAGGACTCTGCCTCGT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F2-3′RACE Nested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ACCGATGTTGCCAATGCTGTT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R2-5′RACE Nested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ACAGTCAGTGCCGTCAAGAAC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taseF2-3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CATGCAGAGTGGAGGACAGGCT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taseR2-5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GCAGTCCACATCCAGGGCTG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745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taseF3-3′RACE Nested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GTGATCGCTGGGACACTTGG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302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taseR2-5′RACE Nested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GCAGTCCACATCCAGGGCTG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F2-3′RACE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GCTCAATTGTCTTCCAGGAAC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R2-5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ACCAAAGCCAAGCCATACAGGA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KF2-3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TAAGCGGCTATACGGCTCTGGTC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KR2-5′RACE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TTGCCACAACCGTAACTTCCAC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726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KF3-3′RACE Nested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GATCATCGACGCCATACACGA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252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KR2-5′RACE Nested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TTGCCACAACCGTAACTTCCA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UPM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TAATACGACTCACTATAGGG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NUP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AGCAGTGGTATCAACGCAGT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ACE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F5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GAAAGCGAGTTGACTG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Full-length</a:t>
                      </a:r>
                      <a:r>
                        <a:rPr lang="en-US" sz="900" baseline="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cDNA cloning</a:t>
                      </a:r>
                      <a:endParaRPr lang="en-US" sz="900" dirty="0" smtClean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KR5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ATCTGACCCGTGCAAAGAT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22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Full-length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4767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ゴシック"/>
                          <a:cs typeface="Courier New" panose="02070309020205020404" pitchFamily="49" charset="0"/>
                        </a:rPr>
                        <a:t>Sr</a:t>
                      </a: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PEPtaseF4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TGCAGGGAAGGGAGGATTT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Full-length</a:t>
                      </a:r>
                      <a:r>
                        <a:rPr lang="en-US" sz="900" baseline="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cDNA cloning</a:t>
                      </a:r>
                      <a:endParaRPr lang="en-US" sz="900" dirty="0" smtClean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4767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taseR3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GTACCCAAAAAGGGCTGCT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22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Full-length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F3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TTCCTGTGCCTAATCGAG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Full-length</a:t>
                      </a:r>
                      <a:r>
                        <a:rPr lang="en-US" sz="900" baseline="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cDNA cloning</a:t>
                      </a:r>
                      <a:endParaRPr lang="en-US" sz="900" dirty="0" smtClean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R3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CAATTCTGCAGCTGATTT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22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Full-length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KF4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GGCCTTCTTGTTGTTTGA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Full-length</a:t>
                      </a:r>
                      <a:r>
                        <a:rPr lang="en-US" sz="900" baseline="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cDNA cloning</a:t>
                      </a:r>
                      <a:endParaRPr lang="en-US" sz="900" dirty="0" smtClean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5720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SrPEPCKR3</a:t>
                      </a:r>
                      <a:endParaRPr lang="ja-JP" sz="900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TCATTCCCCAACGTATGCT</a:t>
                      </a:r>
                      <a:endParaRPr lang="ja-JP" sz="90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22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Full-length cDNA cloning</a:t>
                      </a: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447675" indent="0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PKF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GAGATGCCGGTGCAAAAT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PKR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TCATGTCGATGTTGTTGGG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PEPtaseF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TTGGGGCCGTTTTGTTGA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PEPtaseR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TCCCCCAGATCATGCCTGT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PEPCF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ATTTGTTGGCCAGTGGGAT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PEPCR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TCACCAGAAGCGCAAAGTG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PEPCKF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ATAATGCTGCACCCCACA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PEPCKR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TGCCACAACCGTAACTTCC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AOXF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AGGAGATCGACAACGGGACCATC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AOXR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TGGTAATGGATGTCCGAGGCAAA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EF1αF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ACATGGGGCTCTTCAGCA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 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497">
                <a:tc>
                  <a:txBody>
                    <a:bodyPr/>
                    <a:lstStyle/>
                    <a:p>
                      <a:pPr marL="0" indent="447675"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rtEF1αR1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CCACTCATTATAACTAGTCAACATGCG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 </a:t>
                      </a:r>
                      <a:r>
                        <a:rPr kumimoji="0" lang="en-US" altLang="ja-JP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ＭＳ 明朝"/>
                          <a:cs typeface="Courier New" panose="02070309020205020404" pitchFamily="49" charset="0"/>
                        </a:rPr>
                        <a:t>qRT-PCR</a:t>
                      </a:r>
                      <a:endParaRPr lang="ja-JP" sz="900" dirty="0">
                        <a:effectLst/>
                        <a:latin typeface="Courier New" panose="02070309020205020404" pitchFamily="49" charset="0"/>
                        <a:ea typeface="ＭＳ 明朝"/>
                        <a:cs typeface="Courier New" panose="02070309020205020404" pitchFamily="49" charset="0"/>
                      </a:endParaRPr>
                    </a:p>
                  </a:txBody>
                  <a:tcPr marL="55470" marR="554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891639" y="356224"/>
            <a:ext cx="519526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Supplementary Table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/>
                <a:cs typeface="Arial" panose="020B0604020202020204" pitchFamily="34" charset="0"/>
              </a:rPr>
              <a:t>2</a:t>
            </a:r>
            <a:r>
              <a:rPr kumimoji="1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. Sequences of the primer used in this study.</a:t>
            </a:r>
            <a:endParaRPr kumimoji="1" lang="en-US" altLang="ja-JP" sz="3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6874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98</TotalTime>
  <Words>163</Words>
  <Application>Microsoft Office PowerPoint</Application>
  <PresentationFormat>画面に合わせる (4:3)</PresentationFormat>
  <Paragraphs>14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Theme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viewer</dc:creator>
  <cp:lastModifiedBy>Kikukatsu Ito</cp:lastModifiedBy>
  <cp:revision>367</cp:revision>
  <cp:lastPrinted>2016-09-21T04:13:31Z</cp:lastPrinted>
  <dcterms:created xsi:type="dcterms:W3CDTF">2016-01-08T01:07:56Z</dcterms:created>
  <dcterms:modified xsi:type="dcterms:W3CDTF">2016-10-05T23:28:57Z</dcterms:modified>
</cp:coreProperties>
</file>